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1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84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6719C"/>
    <a:srgbClr val="555AD3"/>
    <a:srgbClr val="0068F0"/>
    <a:srgbClr val="FF9694"/>
    <a:srgbClr val="FF9D9D"/>
    <a:srgbClr val="CF6154"/>
    <a:srgbClr val="8FAADC"/>
    <a:srgbClr val="C5E0B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83"/>
    <p:restoredTop sz="94672"/>
  </p:normalViewPr>
  <p:slideViewPr>
    <p:cSldViewPr snapToGrid="0" snapToObjects="1">
      <p:cViewPr varScale="1">
        <p:scale>
          <a:sx n="86" d="100"/>
          <a:sy n="86" d="100"/>
        </p:scale>
        <p:origin x="3528" y="200"/>
      </p:cViewPr>
      <p:guideLst>
        <p:guide orient="horz" pos="3384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DB6FC9-0008-A043-AB12-BDE08D1EC6B5}" type="datetimeFigureOut">
              <a:rPr lang="en-US" smtClean="0"/>
              <a:t>5/16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5C9DFC-CA46-4242-8D78-02FCC6C317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785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828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232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444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178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032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109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8785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569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550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865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443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40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B33D9ED-F9E2-764E-B394-BC5EB834B255}"/>
              </a:ext>
            </a:extLst>
          </p:cNvPr>
          <p:cNvSpPr txBox="1"/>
          <p:nvPr/>
        </p:nvSpPr>
        <p:spPr>
          <a:xfrm>
            <a:off x="87308" y="9642037"/>
            <a:ext cx="18074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Supplementary Figure S1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3A6991AD-7AB3-0F47-80E6-522DEFC45B5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078" t="7185" r="9895" b="79986"/>
          <a:stretch/>
        </p:blipFill>
        <p:spPr>
          <a:xfrm>
            <a:off x="1211955" y="15729"/>
            <a:ext cx="4380438" cy="746825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DAA030F0-F88A-8B4A-B789-4FC8CBE3BDF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170" t="17918" r="1053" b="727"/>
          <a:stretch/>
        </p:blipFill>
        <p:spPr>
          <a:xfrm>
            <a:off x="1211955" y="735516"/>
            <a:ext cx="4380438" cy="3750830"/>
          </a:xfrm>
          <a:prstGeom prst="rect">
            <a:avLst/>
          </a:prstGeom>
        </p:spPr>
      </p:pic>
      <p:grpSp>
        <p:nvGrpSpPr>
          <p:cNvPr id="25" name="Group 24">
            <a:extLst>
              <a:ext uri="{FF2B5EF4-FFF2-40B4-BE49-F238E27FC236}">
                <a16:creationId xmlns:a16="http://schemas.microsoft.com/office/drawing/2014/main" id="{BBFFEBA2-A170-CB43-A5AF-1B3D2B31B6C0}"/>
              </a:ext>
            </a:extLst>
          </p:cNvPr>
          <p:cNvGrpSpPr/>
          <p:nvPr/>
        </p:nvGrpSpPr>
        <p:grpSpPr>
          <a:xfrm>
            <a:off x="1214892" y="4487043"/>
            <a:ext cx="4375002" cy="1577355"/>
            <a:chOff x="1214892" y="4549535"/>
            <a:chExt cx="4375002" cy="1577355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BD5F435-DC38-0C47-8212-1BA754FB8537}"/>
                </a:ext>
              </a:extLst>
            </p:cNvPr>
            <p:cNvSpPr txBox="1"/>
            <p:nvPr/>
          </p:nvSpPr>
          <p:spPr>
            <a:xfrm rot="16200000">
              <a:off x="963862" y="4800566"/>
              <a:ext cx="62517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Deor_PPA0299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1D8A8E7-8A3D-EB4D-8C0F-5B14D941AFF4}"/>
                </a:ext>
              </a:extLst>
            </p:cNvPr>
            <p:cNvSpPr txBox="1"/>
            <p:nvPr/>
          </p:nvSpPr>
          <p:spPr>
            <a:xfrm rot="16200000">
              <a:off x="1082290" y="4816596"/>
              <a:ext cx="65723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PTR.1_PPA018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03F1532-A63A-F148-A909-4F9EFF9D56A2}"/>
                </a:ext>
              </a:extLst>
            </p:cNvPr>
            <p:cNvSpPr txBox="1"/>
            <p:nvPr/>
          </p:nvSpPr>
          <p:spPr>
            <a:xfrm rot="16200000">
              <a:off x="2094148" y="5276657"/>
              <a:ext cx="15773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Endoacetylglucosaminidase_PPA099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CCABCA3-B5BA-1842-BD73-15A5AE43DC78}"/>
                </a:ext>
              </a:extLst>
            </p:cNvPr>
            <p:cNvSpPr txBox="1"/>
            <p:nvPr/>
          </p:nvSpPr>
          <p:spPr>
            <a:xfrm rot="16200000">
              <a:off x="1131470" y="5049031"/>
              <a:ext cx="1122103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Hyaluronate.HYL_PPA0380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97D3C60-0C52-1A44-90D8-C4A7189F4D00}"/>
                </a:ext>
              </a:extLst>
            </p:cNvPr>
            <p:cNvSpPr txBox="1"/>
            <p:nvPr/>
          </p:nvSpPr>
          <p:spPr>
            <a:xfrm rot="16200000">
              <a:off x="1729095" y="4847052"/>
              <a:ext cx="71814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DnaK.1_PPA1098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A207578-930D-2A48-9651-69AB607760F6}"/>
                </a:ext>
              </a:extLst>
            </p:cNvPr>
            <p:cNvSpPr txBox="1"/>
            <p:nvPr/>
          </p:nvSpPr>
          <p:spPr>
            <a:xfrm rot="16200000">
              <a:off x="2688993" y="4813389"/>
              <a:ext cx="650819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Dsa.1_PPA2127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CA08F5F-1BE4-F448-82AB-BFEFD40896DB}"/>
                </a:ext>
              </a:extLst>
            </p:cNvPr>
            <p:cNvSpPr txBox="1"/>
            <p:nvPr/>
          </p:nvSpPr>
          <p:spPr>
            <a:xfrm rot="16200000">
              <a:off x="1222499" y="4816596"/>
              <a:ext cx="65723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PTR.4_PPA1906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FCBDA36-659D-0A4A-80EB-1A5BF028DDF9}"/>
                </a:ext>
              </a:extLst>
            </p:cNvPr>
            <p:cNvSpPr txBox="1"/>
            <p:nvPr/>
          </p:nvSpPr>
          <p:spPr>
            <a:xfrm rot="16200000">
              <a:off x="1489438" y="4816596"/>
              <a:ext cx="65723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PTR.6_PPA2270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124D461-8B85-D541-A822-6D7954CBBC03}"/>
                </a:ext>
              </a:extLst>
            </p:cNvPr>
            <p:cNvSpPr txBox="1"/>
            <p:nvPr/>
          </p:nvSpPr>
          <p:spPr>
            <a:xfrm rot="16200000">
              <a:off x="1627670" y="4816596"/>
              <a:ext cx="65723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PTR.3_PPA1879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29FDBA1-8FC6-414B-AD35-8F87DEFC3345}"/>
                </a:ext>
              </a:extLst>
            </p:cNvPr>
            <p:cNvSpPr txBox="1"/>
            <p:nvPr/>
          </p:nvSpPr>
          <p:spPr>
            <a:xfrm rot="16200000">
              <a:off x="1891434" y="4816596"/>
              <a:ext cx="65723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PTR.2_PPA1715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E7E31168-8232-4B4C-9DA4-1E32E337CB19}"/>
                </a:ext>
              </a:extLst>
            </p:cNvPr>
            <p:cNvSpPr txBox="1"/>
            <p:nvPr/>
          </p:nvSpPr>
          <p:spPr>
            <a:xfrm rot="16200000">
              <a:off x="1972051" y="4864686"/>
              <a:ext cx="75341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CAMP.2_PPA0687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D2BB9A7-1407-404E-9837-4EE47F72766E}"/>
                </a:ext>
              </a:extLst>
            </p:cNvPr>
            <p:cNvSpPr txBox="1"/>
            <p:nvPr/>
          </p:nvSpPr>
          <p:spPr>
            <a:xfrm rot="16200000">
              <a:off x="2148848" y="4816596"/>
              <a:ext cx="65723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PTR.5_PPA2130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518335C-97FB-5746-821D-FD7BEFC26A2B}"/>
                </a:ext>
              </a:extLst>
            </p:cNvPr>
            <p:cNvSpPr txBox="1"/>
            <p:nvPr/>
          </p:nvSpPr>
          <p:spPr>
            <a:xfrm rot="16200000">
              <a:off x="2187663" y="4919188"/>
              <a:ext cx="862416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Sialidase.3_PPA1560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9F18D5C-FEA6-1C4B-9618-7129F886FFF9}"/>
                </a:ext>
              </a:extLst>
            </p:cNvPr>
            <p:cNvSpPr txBox="1"/>
            <p:nvPr/>
          </p:nvSpPr>
          <p:spPr>
            <a:xfrm rot="16200000">
              <a:off x="2388203" y="4851862"/>
              <a:ext cx="72776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GehA.1_PPA1796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9274F23B-D586-AB49-BE20-01251763B8C4}"/>
                </a:ext>
              </a:extLst>
            </p:cNvPr>
            <p:cNvSpPr txBox="1"/>
            <p:nvPr/>
          </p:nvSpPr>
          <p:spPr>
            <a:xfrm rot="16200000">
              <a:off x="2445345" y="5192500"/>
              <a:ext cx="1409040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Endoglycoceramidase.2_PPA2106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1BD1D147-5748-1D4E-9EE9-E08AC6850852}"/>
                </a:ext>
              </a:extLst>
            </p:cNvPr>
            <p:cNvSpPr txBox="1"/>
            <p:nvPr/>
          </p:nvSpPr>
          <p:spPr>
            <a:xfrm rot="16200000">
              <a:off x="2917764" y="4851862"/>
              <a:ext cx="72776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GehA.2_PPA2105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844C541-5AB0-1B4E-A389-F312429ED9CE}"/>
                </a:ext>
              </a:extLst>
            </p:cNvPr>
            <p:cNvSpPr txBox="1"/>
            <p:nvPr/>
          </p:nvSpPr>
          <p:spPr>
            <a:xfrm rot="16200000">
              <a:off x="3030168" y="4864686"/>
              <a:ext cx="75341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CAMP.1_PPA1340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07CB587-5859-3F44-A003-873F437FB1DD}"/>
                </a:ext>
              </a:extLst>
            </p:cNvPr>
            <p:cNvSpPr txBox="1"/>
            <p:nvPr/>
          </p:nvSpPr>
          <p:spPr>
            <a:xfrm rot="16200000">
              <a:off x="3213461" y="4813390"/>
              <a:ext cx="650819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Dsa.2_PPA2210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F0FF1E0C-0158-2748-866E-3E805F7A99CA}"/>
                </a:ext>
              </a:extLst>
            </p:cNvPr>
            <p:cNvSpPr txBox="1"/>
            <p:nvPr/>
          </p:nvSpPr>
          <p:spPr>
            <a:xfrm rot="16200000">
              <a:off x="2971734" y="5192500"/>
              <a:ext cx="1409040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Endoglycoceramidase.1_PPA0644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8D13E6F2-5CE0-B94E-9A78-4D0C48D559EB}"/>
                </a:ext>
              </a:extLst>
            </p:cNvPr>
            <p:cNvSpPr txBox="1"/>
            <p:nvPr/>
          </p:nvSpPr>
          <p:spPr>
            <a:xfrm rot="16200000">
              <a:off x="3376308" y="4919188"/>
              <a:ext cx="862416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Sialidase.2_PPA0685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9B43FF4B-8B92-D543-AB9E-C433FCADE9DA}"/>
                </a:ext>
              </a:extLst>
            </p:cNvPr>
            <p:cNvSpPr txBox="1"/>
            <p:nvPr/>
          </p:nvSpPr>
          <p:spPr>
            <a:xfrm rot="16200000">
              <a:off x="3559517" y="4864686"/>
              <a:ext cx="75341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CAMP.5_PPA1198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83C0B25D-6CAE-1C40-BC35-B969B9D2DE0F}"/>
                </a:ext>
              </a:extLst>
            </p:cNvPr>
            <p:cNvSpPr txBox="1"/>
            <p:nvPr/>
          </p:nvSpPr>
          <p:spPr>
            <a:xfrm rot="16200000">
              <a:off x="3643247" y="4919188"/>
              <a:ext cx="862416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Sialidase.1_PPA0684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05E87A3D-39A0-4745-A50D-A62DB581C9ED}"/>
                </a:ext>
              </a:extLst>
            </p:cNvPr>
            <p:cNvSpPr txBox="1"/>
            <p:nvPr/>
          </p:nvSpPr>
          <p:spPr>
            <a:xfrm rot="16200000">
              <a:off x="3868539" y="4957661"/>
              <a:ext cx="93936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Hemolysin.1_PPA0565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2B5CF41F-1BE6-1B45-AEF1-D1945A962228}"/>
                </a:ext>
              </a:extLst>
            </p:cNvPr>
            <p:cNvSpPr txBox="1"/>
            <p:nvPr/>
          </p:nvSpPr>
          <p:spPr>
            <a:xfrm rot="16200000">
              <a:off x="3630889" y="5060253"/>
              <a:ext cx="114454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Hemolysin.3.TlyA_PPA1396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21DE659F-357C-2D48-A352-B906C615D7ED}"/>
                </a:ext>
              </a:extLst>
            </p:cNvPr>
            <p:cNvSpPr txBox="1"/>
            <p:nvPr/>
          </p:nvSpPr>
          <p:spPr>
            <a:xfrm rot="16200000">
              <a:off x="4107853" y="4847053"/>
              <a:ext cx="71814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DnaK.2_PPA2040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E93192BB-1A5A-B543-B507-BF3DD0F8398D}"/>
                </a:ext>
              </a:extLst>
            </p:cNvPr>
            <p:cNvSpPr txBox="1"/>
            <p:nvPr/>
          </p:nvSpPr>
          <p:spPr>
            <a:xfrm rot="16200000">
              <a:off x="4229285" y="4860679"/>
              <a:ext cx="745397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GroEL.1_PPA0453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E9F618CE-235F-6A45-B761-E872AC06C754}"/>
                </a:ext>
              </a:extLst>
            </p:cNvPr>
            <p:cNvSpPr txBox="1"/>
            <p:nvPr/>
          </p:nvSpPr>
          <p:spPr>
            <a:xfrm rot="16200000">
              <a:off x="4485866" y="4864686"/>
              <a:ext cx="75341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CAMP.4_PPA1231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43280510-BD22-3E4A-A543-D3BCED5DA3AE}"/>
                </a:ext>
              </a:extLst>
            </p:cNvPr>
            <p:cNvSpPr txBox="1"/>
            <p:nvPr/>
          </p:nvSpPr>
          <p:spPr>
            <a:xfrm rot="16200000">
              <a:off x="4357992" y="4860679"/>
              <a:ext cx="745397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GroEL.2_PPA1772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AF528E73-168E-F54D-A619-4F7293CFD18E}"/>
                </a:ext>
              </a:extLst>
            </p:cNvPr>
            <p:cNvSpPr txBox="1"/>
            <p:nvPr/>
          </p:nvSpPr>
          <p:spPr>
            <a:xfrm rot="16200000">
              <a:off x="4648976" y="4836634"/>
              <a:ext cx="697307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DnaJ.2_PPA2038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ACC9AAD6-DF50-A247-929C-7B6684E2C900}"/>
                </a:ext>
              </a:extLst>
            </p:cNvPr>
            <p:cNvSpPr txBox="1"/>
            <p:nvPr/>
          </p:nvSpPr>
          <p:spPr>
            <a:xfrm rot="16200000">
              <a:off x="4756813" y="4860679"/>
              <a:ext cx="745397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GroEL.3_PPA1773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B5D6C07-5020-8A40-880D-C7980CBA4055}"/>
                </a:ext>
              </a:extLst>
            </p:cNvPr>
            <p:cNvSpPr txBox="1"/>
            <p:nvPr/>
          </p:nvSpPr>
          <p:spPr>
            <a:xfrm rot="16200000">
              <a:off x="4881512" y="4864686"/>
              <a:ext cx="75341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CAMP.3_PPA2108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737975F3-DE80-2740-B262-F57FDA7C917A}"/>
                </a:ext>
              </a:extLst>
            </p:cNvPr>
            <p:cNvSpPr txBox="1"/>
            <p:nvPr/>
          </p:nvSpPr>
          <p:spPr>
            <a:xfrm rot="16200000">
              <a:off x="5179685" y="4836634"/>
              <a:ext cx="697307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DnaJ.1_PPA0916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D42F7F24-BDE0-9340-80EB-3A2AF0860696}"/>
                </a:ext>
              </a:extLst>
            </p:cNvPr>
            <p:cNvSpPr txBox="1"/>
            <p:nvPr/>
          </p:nvSpPr>
          <p:spPr>
            <a:xfrm rot="16200000">
              <a:off x="4813019" y="5065061"/>
              <a:ext cx="115416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dirty="0">
                  <a:cs typeface="Arial" panose="020B0604020202020204" pitchFamily="34" charset="0"/>
                </a:rPr>
                <a:t>Hemolysin.2.HylC_PPA0938</a:t>
              </a: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D7A3E031-54D3-494D-8A19-5D8CB3C4E128}"/>
              </a:ext>
            </a:extLst>
          </p:cNvPr>
          <p:cNvGrpSpPr/>
          <p:nvPr/>
        </p:nvGrpSpPr>
        <p:grpSpPr>
          <a:xfrm>
            <a:off x="56840" y="693996"/>
            <a:ext cx="1142951" cy="3854514"/>
            <a:chOff x="56840" y="845489"/>
            <a:chExt cx="1142951" cy="3854514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B4E1C6BF-46DE-E249-83EC-E5EA6974B5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90666" t="19660" r="6965" b="14987"/>
            <a:stretch/>
          </p:blipFill>
          <p:spPr>
            <a:xfrm>
              <a:off x="780002" y="883835"/>
              <a:ext cx="162508" cy="3750829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9A430FD3-816F-4542-B3B5-B55FF461E5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9435" r="89111" b="15046"/>
            <a:stretch/>
          </p:blipFill>
          <p:spPr>
            <a:xfrm>
              <a:off x="56840" y="871134"/>
              <a:ext cx="746745" cy="3763530"/>
            </a:xfrm>
            <a:prstGeom prst="rect">
              <a:avLst/>
            </a:prstGeom>
          </p:spPr>
        </p:pic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8FFBB811-C36A-6445-A00E-DB21CBE0B3E6}"/>
                </a:ext>
              </a:extLst>
            </p:cNvPr>
            <p:cNvSpPr/>
            <p:nvPr/>
          </p:nvSpPr>
          <p:spPr>
            <a:xfrm>
              <a:off x="888895" y="3866024"/>
              <a:ext cx="310896" cy="685800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9606A5B-34CE-234E-8C4B-2DDBBA6AAC9E}"/>
                </a:ext>
              </a:extLst>
            </p:cNvPr>
            <p:cNvSpPr txBox="1"/>
            <p:nvPr/>
          </p:nvSpPr>
          <p:spPr>
            <a:xfrm>
              <a:off x="891898" y="3872763"/>
              <a:ext cx="3048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/>
                <a:t>IIB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ACFB9CD3-27BA-F741-9697-64CE693F8BE6}"/>
                </a:ext>
              </a:extLst>
            </p:cNvPr>
            <p:cNvSpPr/>
            <p:nvPr/>
          </p:nvSpPr>
          <p:spPr>
            <a:xfrm>
              <a:off x="888895" y="899710"/>
              <a:ext cx="310896" cy="2966252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75BE339-4645-544C-ABF6-652DEE555357}"/>
                </a:ext>
              </a:extLst>
            </p:cNvPr>
            <p:cNvSpPr txBox="1"/>
            <p:nvPr/>
          </p:nvSpPr>
          <p:spPr>
            <a:xfrm>
              <a:off x="937583" y="2446026"/>
              <a:ext cx="21352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cs typeface="Arial" panose="020B0604020202020204" pitchFamily="34" charset="0"/>
                </a:rPr>
                <a:t>I</a:t>
              </a:r>
              <a:endParaRPr lang="en-US" sz="900" baseline="-25000" dirty="0">
                <a:cs typeface="Arial" panose="020B0604020202020204" pitchFamily="34" charset="0"/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77BA150F-2431-9A49-BC45-D1A57ED38411}"/>
                </a:ext>
              </a:extLst>
            </p:cNvPr>
            <p:cNvSpPr/>
            <p:nvPr/>
          </p:nvSpPr>
          <p:spPr>
            <a:xfrm>
              <a:off x="888895" y="4551886"/>
              <a:ext cx="310896" cy="76428"/>
            </a:xfrm>
            <a:prstGeom prst="rect">
              <a:avLst/>
            </a:prstGeom>
            <a:solidFill>
              <a:srgbClr val="FF9D9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5EF2725-DFD3-5A4C-B75D-BA5824B437F0}"/>
                </a:ext>
              </a:extLst>
            </p:cNvPr>
            <p:cNvSpPr txBox="1"/>
            <p:nvPr/>
          </p:nvSpPr>
          <p:spPr>
            <a:xfrm>
              <a:off x="908729" y="4469171"/>
              <a:ext cx="2712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/>
                <a:t>III</a:t>
              </a:r>
            </a:p>
          </p:txBody>
        </p: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068AB0D7-ACC4-B447-A34B-DBE24F313401}"/>
                </a:ext>
              </a:extLst>
            </p:cNvPr>
            <p:cNvGrpSpPr/>
            <p:nvPr/>
          </p:nvGrpSpPr>
          <p:grpSpPr>
            <a:xfrm>
              <a:off x="298644" y="845489"/>
              <a:ext cx="431061" cy="649321"/>
              <a:chOff x="308941" y="842390"/>
              <a:chExt cx="431061" cy="649321"/>
            </a:xfrm>
          </p:grpSpPr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C2D516B0-2316-764E-BFB4-64FDFFF6815A}"/>
                  </a:ext>
                </a:extLst>
              </p:cNvPr>
              <p:cNvSpPr/>
              <p:nvPr/>
            </p:nvSpPr>
            <p:spPr>
              <a:xfrm rot="5400000">
                <a:off x="348541" y="1025259"/>
                <a:ext cx="274320" cy="5486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9B0E1FE2-E583-9C44-8029-F9F473599FD0}"/>
                  </a:ext>
                </a:extLst>
              </p:cNvPr>
              <p:cNvSpPr/>
              <p:nvPr/>
            </p:nvSpPr>
            <p:spPr>
              <a:xfrm rot="5400000">
                <a:off x="284888" y="1196928"/>
                <a:ext cx="402336" cy="54864"/>
              </a:xfrm>
              <a:prstGeom prst="rect">
                <a:avLst/>
              </a:prstGeom>
              <a:gradFill flip="none" rotWithShape="1">
                <a:gsLst>
                  <a:gs pos="0">
                    <a:schemeClr val="accent5">
                      <a:lumMod val="20000"/>
                      <a:lumOff val="80000"/>
                    </a:schemeClr>
                  </a:gs>
                  <a:gs pos="33000">
                    <a:schemeClr val="accent5">
                      <a:lumMod val="40000"/>
                      <a:lumOff val="60000"/>
                    </a:schemeClr>
                  </a:gs>
                  <a:gs pos="56000">
                    <a:schemeClr val="accent5">
                      <a:lumMod val="60000"/>
                      <a:lumOff val="40000"/>
                    </a:schemeClr>
                  </a:gs>
                  <a:gs pos="97000">
                    <a:schemeClr val="accent5">
                      <a:lumMod val="70000"/>
                    </a:schemeClr>
                  </a:gs>
                </a:gsLst>
                <a:lin ang="0" scaled="1"/>
                <a:tileRect/>
              </a:gra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242DF897-E860-C341-90A7-EEBD85570C01}"/>
                  </a:ext>
                </a:extLst>
              </p:cNvPr>
              <p:cNvSpPr txBox="1"/>
              <p:nvPr/>
            </p:nvSpPr>
            <p:spPr>
              <a:xfrm>
                <a:off x="445577" y="842390"/>
                <a:ext cx="22313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0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9FD0160B-FC0A-3048-AD52-669C7E8C9275}"/>
                  </a:ext>
                </a:extLst>
              </p:cNvPr>
              <p:cNvSpPr txBox="1"/>
              <p:nvPr/>
            </p:nvSpPr>
            <p:spPr>
              <a:xfrm>
                <a:off x="446869" y="960358"/>
                <a:ext cx="2616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70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E1EC730B-81DD-CE44-AFA5-262AF946FA90}"/>
                  </a:ext>
                </a:extLst>
              </p:cNvPr>
              <p:cNvSpPr txBox="1"/>
              <p:nvPr/>
            </p:nvSpPr>
            <p:spPr>
              <a:xfrm>
                <a:off x="439920" y="1307045"/>
                <a:ext cx="30008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100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46A8E2F0-8630-1042-9F9D-FBD17EC62AD6}"/>
                  </a:ext>
                </a:extLst>
              </p:cNvPr>
              <p:cNvSpPr txBox="1"/>
              <p:nvPr/>
            </p:nvSpPr>
            <p:spPr>
              <a:xfrm rot="16200000">
                <a:off x="152648" y="1118221"/>
                <a:ext cx="49725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% identity</a:t>
                </a:r>
              </a:p>
            </p:txBody>
          </p: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869A92A0-C8B7-1141-B1D7-7E0BF2A49129}"/>
                  </a:ext>
                </a:extLst>
              </p:cNvPr>
              <p:cNvCxnSpPr/>
              <p:nvPr/>
            </p:nvCxnSpPr>
            <p:spPr>
              <a:xfrm>
                <a:off x="502417" y="914573"/>
                <a:ext cx="27432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2B03BB2B-5DC6-444A-9AB4-96600FB89494}"/>
                  </a:ext>
                </a:extLst>
              </p:cNvPr>
              <p:cNvCxnSpPr/>
              <p:nvPr/>
            </p:nvCxnSpPr>
            <p:spPr>
              <a:xfrm>
                <a:off x="502417" y="1022523"/>
                <a:ext cx="27432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F7A3A904-AB9F-3E4A-B0FC-788D46A511D1}"/>
                  </a:ext>
                </a:extLst>
              </p:cNvPr>
              <p:cNvCxnSpPr/>
              <p:nvPr/>
            </p:nvCxnSpPr>
            <p:spPr>
              <a:xfrm>
                <a:off x="502417" y="1425748"/>
                <a:ext cx="27432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8E899B0D-8ACA-C441-99CE-2C1E1751BAA6}"/>
                </a:ext>
              </a:extLst>
            </p:cNvPr>
            <p:cNvSpPr txBox="1"/>
            <p:nvPr/>
          </p:nvSpPr>
          <p:spPr>
            <a:xfrm>
              <a:off x="889493" y="4142442"/>
              <a:ext cx="30970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/>
                <a:t>IIA</a:t>
              </a:r>
            </a:p>
          </p:txBody>
        </p: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49034F13-6828-E746-BDFA-66453D2D1059}"/>
                </a:ext>
              </a:extLst>
            </p:cNvPr>
            <p:cNvCxnSpPr>
              <a:cxnSpLocks/>
            </p:cNvCxnSpPr>
            <p:nvPr/>
          </p:nvCxnSpPr>
          <p:spPr>
            <a:xfrm>
              <a:off x="888547" y="4113759"/>
              <a:ext cx="310896" cy="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500B8F4E-7E11-3449-A2E5-FDB454452EC4}"/>
                </a:ext>
              </a:extLst>
            </p:cNvPr>
            <p:cNvSpPr/>
            <p:nvPr/>
          </p:nvSpPr>
          <p:spPr>
            <a:xfrm>
              <a:off x="888895" y="4407730"/>
              <a:ext cx="310896" cy="107699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E4CFBAF8-EFD6-D846-8891-6E25FC5C78FD}"/>
                </a:ext>
              </a:extLst>
            </p:cNvPr>
            <p:cNvSpPr txBox="1"/>
            <p:nvPr/>
          </p:nvSpPr>
          <p:spPr>
            <a:xfrm>
              <a:off x="937583" y="4348837"/>
              <a:ext cx="21352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/>
                <a:t>I</a:t>
              </a:r>
            </a:p>
          </p:txBody>
        </p:sp>
      </p:grpSp>
      <p:pic>
        <p:nvPicPr>
          <p:cNvPr id="34" name="Picture 33">
            <a:extLst>
              <a:ext uri="{FF2B5EF4-FFF2-40B4-BE49-F238E27FC236}">
                <a16:creationId xmlns:a16="http://schemas.microsoft.com/office/drawing/2014/main" id="{CAB223B1-7BA5-2C41-AAF6-805F3992957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1419" t="18104" r="25990" b="3212"/>
          <a:stretch/>
        </p:blipFill>
        <p:spPr>
          <a:xfrm>
            <a:off x="1347562" y="6259500"/>
            <a:ext cx="4096399" cy="3447409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9A59820E-927C-9F46-A741-BB5C261A217B}"/>
              </a:ext>
            </a:extLst>
          </p:cNvPr>
          <p:cNvSpPr txBox="1"/>
          <p:nvPr/>
        </p:nvSpPr>
        <p:spPr>
          <a:xfrm>
            <a:off x="-33942" y="-60584"/>
            <a:ext cx="3445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A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54EE8C7-7791-9543-9B73-A00980F7FAFD}"/>
              </a:ext>
            </a:extLst>
          </p:cNvPr>
          <p:cNvSpPr txBox="1"/>
          <p:nvPr/>
        </p:nvSpPr>
        <p:spPr>
          <a:xfrm>
            <a:off x="0" y="6077246"/>
            <a:ext cx="3445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AFA4800-B41D-734B-BFBD-5D05306F7881}"/>
              </a:ext>
            </a:extLst>
          </p:cNvPr>
          <p:cNvSpPr txBox="1"/>
          <p:nvPr/>
        </p:nvSpPr>
        <p:spPr>
          <a:xfrm>
            <a:off x="2999814" y="7751478"/>
            <a:ext cx="79380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900" dirty="0"/>
              <a:t>KPA171202</a:t>
            </a:r>
          </a:p>
          <a:p>
            <a:pPr algn="ctr"/>
            <a:r>
              <a:rPr lang="en-US" sz="900" dirty="0"/>
              <a:t>2,560,265 bp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A7FFBAA-7A13-B241-BC45-C1407F1E758C}"/>
              </a:ext>
            </a:extLst>
          </p:cNvPr>
          <p:cNvSpPr txBox="1"/>
          <p:nvPr/>
        </p:nvSpPr>
        <p:spPr>
          <a:xfrm>
            <a:off x="3196758" y="7395315"/>
            <a:ext cx="1236130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>
                <a:solidFill>
                  <a:srgbClr val="C00000"/>
                </a:solidFill>
              </a:rPr>
              <a:t>hyalorunate lyase PPA038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A9566A0-8BB7-0644-80A0-E512D7EABE92}"/>
              </a:ext>
            </a:extLst>
          </p:cNvPr>
          <p:cNvSpPr txBox="1"/>
          <p:nvPr/>
        </p:nvSpPr>
        <p:spPr>
          <a:xfrm>
            <a:off x="3574581" y="7189682"/>
            <a:ext cx="686837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>
                <a:solidFill>
                  <a:srgbClr val="C00000"/>
                </a:solidFill>
              </a:rPr>
              <a:t>deoR PPA0299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523E953-3324-4846-B335-643C665A16DD}"/>
              </a:ext>
            </a:extLst>
          </p:cNvPr>
          <p:cNvSpPr txBox="1"/>
          <p:nvPr/>
        </p:nvSpPr>
        <p:spPr>
          <a:xfrm>
            <a:off x="3078057" y="8111646"/>
            <a:ext cx="1534454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>
                <a:solidFill>
                  <a:srgbClr val="C00000"/>
                </a:solidFill>
              </a:rPr>
              <a:t>endoglycoceramidase.1 PPA0644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6E52D0A-3277-B044-9490-95DFD13ADAA2}"/>
              </a:ext>
            </a:extLst>
          </p:cNvPr>
          <p:cNvSpPr txBox="1"/>
          <p:nvPr/>
        </p:nvSpPr>
        <p:spPr>
          <a:xfrm>
            <a:off x="2651283" y="8213816"/>
            <a:ext cx="1827413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>
                <a:solidFill>
                  <a:srgbClr val="C00000"/>
                </a:solidFill>
              </a:rPr>
              <a:t>sialidase.1 PPA0684, sialidase.2 PPA0685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523B70D-061D-9C4F-A3F4-1A28756FC035}"/>
              </a:ext>
            </a:extLst>
          </p:cNvPr>
          <p:cNvSpPr txBox="1"/>
          <p:nvPr/>
        </p:nvSpPr>
        <p:spPr>
          <a:xfrm>
            <a:off x="3670545" y="8317204"/>
            <a:ext cx="788617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>
                <a:solidFill>
                  <a:srgbClr val="C00000"/>
                </a:solidFill>
              </a:rPr>
              <a:t>CAMP.2 PPA0687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7AE977C-D253-B045-94E3-07F5BF4F4595}"/>
              </a:ext>
            </a:extLst>
          </p:cNvPr>
          <p:cNvSpPr txBox="1"/>
          <p:nvPr/>
        </p:nvSpPr>
        <p:spPr>
          <a:xfrm>
            <a:off x="2690529" y="8950520"/>
            <a:ext cx="706035" cy="94563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rgbClr val="C00000"/>
                </a:solidFill>
              </a:rPr>
              <a:t>CAMP.1 PPA134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B340E7F-A310-F244-BD72-09EF08012F9A}"/>
              </a:ext>
            </a:extLst>
          </p:cNvPr>
          <p:cNvSpPr txBox="1"/>
          <p:nvPr/>
        </p:nvSpPr>
        <p:spPr>
          <a:xfrm>
            <a:off x="2953025" y="9020072"/>
            <a:ext cx="788617" cy="92333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rgbClr val="C00000"/>
                </a:solidFill>
              </a:rPr>
              <a:t>CAMP.4 PPA1231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B6CA17B-47D9-834A-8B2F-C8EBCAB9B72F}"/>
              </a:ext>
            </a:extLst>
          </p:cNvPr>
          <p:cNvSpPr txBox="1"/>
          <p:nvPr/>
        </p:nvSpPr>
        <p:spPr>
          <a:xfrm>
            <a:off x="2420090" y="8481005"/>
            <a:ext cx="896946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solidFill>
                  <a:srgbClr val="C00000"/>
                </a:solidFill>
              </a:rPr>
              <a:t>sialidase.3 PPA156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97F9ACDC-20DB-7C41-8ADE-0B6C46F2EE83}"/>
              </a:ext>
            </a:extLst>
          </p:cNvPr>
          <p:cNvSpPr txBox="1"/>
          <p:nvPr/>
        </p:nvSpPr>
        <p:spPr>
          <a:xfrm>
            <a:off x="34264" y="6640084"/>
            <a:ext cx="2261433" cy="12336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>
                <a:solidFill>
                  <a:srgbClr val="C00000"/>
                </a:solidFill>
              </a:rPr>
              <a:t>endoglycoceramidase.2 PPA0644, CAMP.3 PPA2108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12848C56-C472-5B4A-805D-40EC8DE3EC4A}"/>
              </a:ext>
            </a:extLst>
          </p:cNvPr>
          <p:cNvSpPr txBox="1"/>
          <p:nvPr/>
        </p:nvSpPr>
        <p:spPr>
          <a:xfrm>
            <a:off x="2554109" y="8791414"/>
            <a:ext cx="1250543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solidFill>
                  <a:srgbClr val="C00000"/>
                </a:solidFill>
              </a:rPr>
              <a:t>hemolysin.3 TlyA PPA156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F72BBAB-B58B-B944-B61B-5DBD92DB3EE2}"/>
              </a:ext>
            </a:extLst>
          </p:cNvPr>
          <p:cNvSpPr txBox="1"/>
          <p:nvPr/>
        </p:nvSpPr>
        <p:spPr>
          <a:xfrm>
            <a:off x="2802450" y="9665936"/>
            <a:ext cx="788617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solidFill>
                  <a:srgbClr val="C00000"/>
                </a:solidFill>
              </a:rPr>
              <a:t>CAMP.5 PPA1198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38701BC0-F6C3-304B-9933-B3195D9D1E47}"/>
              </a:ext>
            </a:extLst>
          </p:cNvPr>
          <p:cNvSpPr txBox="1"/>
          <p:nvPr/>
        </p:nvSpPr>
        <p:spPr>
          <a:xfrm>
            <a:off x="4149833" y="9458564"/>
            <a:ext cx="1658692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</a:rPr>
              <a:t>endoacetylglucosaminidase PPA0990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FF2E66D8-2858-AB4F-A172-B6AE4F5DAF35}"/>
              </a:ext>
            </a:extLst>
          </p:cNvPr>
          <p:cNvSpPr txBox="1"/>
          <p:nvPr/>
        </p:nvSpPr>
        <p:spPr>
          <a:xfrm>
            <a:off x="4372786" y="9329682"/>
            <a:ext cx="1248080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</a:rPr>
              <a:t>hemolysin.2.Hylc PPA0938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BE60897-0127-CB4B-9422-14BAC34CAC59}"/>
              </a:ext>
            </a:extLst>
          </p:cNvPr>
          <p:cNvSpPr txBox="1"/>
          <p:nvPr/>
        </p:nvSpPr>
        <p:spPr>
          <a:xfrm>
            <a:off x="5059185" y="7843333"/>
            <a:ext cx="993751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</a:rPr>
              <a:t>hemolysin.1 PPA0565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CA154516-ED5D-AF40-9EEE-3E1841042CA9}"/>
              </a:ext>
            </a:extLst>
          </p:cNvPr>
          <p:cNvSpPr txBox="1"/>
          <p:nvPr/>
        </p:nvSpPr>
        <p:spPr>
          <a:xfrm>
            <a:off x="4452107" y="9215481"/>
            <a:ext cx="731682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</a:rPr>
              <a:t>Dnaj.1 PPA0916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8D613D8B-7571-1848-9627-7F6D0961B18A}"/>
              </a:ext>
            </a:extLst>
          </p:cNvPr>
          <p:cNvSpPr txBox="1"/>
          <p:nvPr/>
        </p:nvSpPr>
        <p:spPr>
          <a:xfrm>
            <a:off x="4004678" y="6442145"/>
            <a:ext cx="704011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solidFill>
                  <a:srgbClr val="C00000"/>
                </a:solidFill>
              </a:rPr>
              <a:t>PTR.1 PPA0180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B462B4CC-0273-634F-925C-E3A361EC10F6}"/>
              </a:ext>
            </a:extLst>
          </p:cNvPr>
          <p:cNvSpPr txBox="1"/>
          <p:nvPr/>
        </p:nvSpPr>
        <p:spPr>
          <a:xfrm>
            <a:off x="1109330" y="7325256"/>
            <a:ext cx="704011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solidFill>
                  <a:srgbClr val="C00000"/>
                </a:solidFill>
              </a:rPr>
              <a:t>PTR.4 PPA1906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C30932BE-1F52-3E44-BA1C-21366947288D}"/>
              </a:ext>
            </a:extLst>
          </p:cNvPr>
          <p:cNvSpPr txBox="1"/>
          <p:nvPr/>
        </p:nvSpPr>
        <p:spPr>
          <a:xfrm>
            <a:off x="2266865" y="6238538"/>
            <a:ext cx="704011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solidFill>
                  <a:srgbClr val="C00000"/>
                </a:solidFill>
              </a:rPr>
              <a:t>PTR.6 PPA2270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C3B2C3A7-1D12-584D-93C2-91F1442B2170}"/>
              </a:ext>
            </a:extLst>
          </p:cNvPr>
          <p:cNvSpPr txBox="1"/>
          <p:nvPr/>
        </p:nvSpPr>
        <p:spPr>
          <a:xfrm>
            <a:off x="2082775" y="7590566"/>
            <a:ext cx="704011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solidFill>
                  <a:srgbClr val="C00000"/>
                </a:solidFill>
              </a:rPr>
              <a:t>PTR.3 PPA1879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DAEFE776-D7A1-6241-A0BA-A20EAA678BE8}"/>
              </a:ext>
            </a:extLst>
          </p:cNvPr>
          <p:cNvSpPr txBox="1"/>
          <p:nvPr/>
        </p:nvSpPr>
        <p:spPr>
          <a:xfrm>
            <a:off x="3468430" y="8911613"/>
            <a:ext cx="581446" cy="92333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rgbClr val="C00000"/>
                </a:solidFill>
              </a:rPr>
              <a:t>Dnak.1 PPA1098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2E97233A-2FCD-AF42-AD61-4DE7CF9986D8}"/>
              </a:ext>
            </a:extLst>
          </p:cNvPr>
          <p:cNvSpPr txBox="1"/>
          <p:nvPr/>
        </p:nvSpPr>
        <p:spPr>
          <a:xfrm>
            <a:off x="1011218" y="8128193"/>
            <a:ext cx="704011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solidFill>
                  <a:srgbClr val="C00000"/>
                </a:solidFill>
              </a:rPr>
              <a:t>PTR.2 PPA1715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C3713430-32DA-9044-98D0-3B89BB25D5B4}"/>
              </a:ext>
            </a:extLst>
          </p:cNvPr>
          <p:cNvSpPr txBox="1"/>
          <p:nvPr/>
        </p:nvSpPr>
        <p:spPr>
          <a:xfrm>
            <a:off x="2676085" y="6996062"/>
            <a:ext cx="704011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</a:rPr>
              <a:t>PTR.5 PPA2130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45B31B47-511A-BB49-90FE-14D25751D8A2}"/>
              </a:ext>
            </a:extLst>
          </p:cNvPr>
          <p:cNvSpPr txBox="1"/>
          <p:nvPr/>
        </p:nvSpPr>
        <p:spPr>
          <a:xfrm>
            <a:off x="949007" y="7754002"/>
            <a:ext cx="760335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solidFill>
                  <a:srgbClr val="C00000"/>
                </a:solidFill>
              </a:rPr>
              <a:t>GehA.1 PPA1796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3E1FA4E8-FC1E-B04B-9793-716A12391CC7}"/>
              </a:ext>
            </a:extLst>
          </p:cNvPr>
          <p:cNvSpPr txBox="1"/>
          <p:nvPr/>
        </p:nvSpPr>
        <p:spPr>
          <a:xfrm>
            <a:off x="1730769" y="6513094"/>
            <a:ext cx="704011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solidFill>
                  <a:srgbClr val="C00000"/>
                </a:solidFill>
              </a:rPr>
              <a:t>Dsa.1 PPA2127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1811C164-9A0C-6B43-8870-71CDF8A314C6}"/>
              </a:ext>
            </a:extLst>
          </p:cNvPr>
          <p:cNvSpPr txBox="1"/>
          <p:nvPr/>
        </p:nvSpPr>
        <p:spPr>
          <a:xfrm>
            <a:off x="2624103" y="7105809"/>
            <a:ext cx="760335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</a:rPr>
              <a:t>GehA.2 PPA1796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B64FA969-4F3B-F440-809C-352F2EFD5657}"/>
              </a:ext>
            </a:extLst>
          </p:cNvPr>
          <p:cNvSpPr txBox="1"/>
          <p:nvPr/>
        </p:nvSpPr>
        <p:spPr>
          <a:xfrm>
            <a:off x="2042989" y="6352076"/>
            <a:ext cx="704011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>
                <a:solidFill>
                  <a:srgbClr val="C00000"/>
                </a:solidFill>
              </a:rPr>
              <a:t>Dsa.2 PPA2210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590C6D72-BD33-734C-B790-139BC5216AD1}"/>
              </a:ext>
            </a:extLst>
          </p:cNvPr>
          <p:cNvSpPr txBox="1"/>
          <p:nvPr/>
        </p:nvSpPr>
        <p:spPr>
          <a:xfrm>
            <a:off x="2520095" y="7228920"/>
            <a:ext cx="760335" cy="24622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800" dirty="0">
                <a:solidFill>
                  <a:srgbClr val="C00000"/>
                </a:solidFill>
              </a:rPr>
              <a:t>Dnaj.2 PPA2038</a:t>
            </a:r>
          </a:p>
          <a:p>
            <a:r>
              <a:rPr lang="en-US" sz="800" dirty="0">
                <a:solidFill>
                  <a:srgbClr val="C00000"/>
                </a:solidFill>
              </a:rPr>
              <a:t>Dnak.2 PPA204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B084C1BE-B6AC-4643-982C-1D3D79D835DD}"/>
              </a:ext>
            </a:extLst>
          </p:cNvPr>
          <p:cNvSpPr txBox="1"/>
          <p:nvPr/>
        </p:nvSpPr>
        <p:spPr>
          <a:xfrm>
            <a:off x="4940729" y="7336943"/>
            <a:ext cx="775630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solidFill>
                  <a:srgbClr val="C00000"/>
                </a:solidFill>
              </a:rPr>
              <a:t>GroEL.1 PPA0453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E80A5A27-D45C-C049-B49F-6A45870B8CDD}"/>
              </a:ext>
            </a:extLst>
          </p:cNvPr>
          <p:cNvSpPr txBox="1"/>
          <p:nvPr/>
        </p:nvSpPr>
        <p:spPr>
          <a:xfrm>
            <a:off x="2000558" y="7867103"/>
            <a:ext cx="841024" cy="24622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solidFill>
                  <a:srgbClr val="C00000"/>
                </a:solidFill>
              </a:rPr>
              <a:t>GroEL.3 PPA1773</a:t>
            </a:r>
          </a:p>
          <a:p>
            <a:pPr algn="ctr"/>
            <a:r>
              <a:rPr lang="en-US" sz="800" dirty="0">
                <a:solidFill>
                  <a:srgbClr val="C00000"/>
                </a:solidFill>
              </a:rPr>
              <a:t> GroEL.2 PPA1772</a:t>
            </a:r>
          </a:p>
        </p:txBody>
      </p:sp>
    </p:spTree>
    <p:extLst>
      <p:ext uri="{BB962C8B-B14F-4D97-AF65-F5344CB8AC3E}">
        <p14:creationId xmlns:p14="http://schemas.microsoft.com/office/powerpoint/2010/main" val="32696511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031</TotalTime>
  <Words>316</Words>
  <Application>Microsoft Macintosh PowerPoint</Application>
  <PresentationFormat>A4 Paper (210x297 mm)</PresentationFormat>
  <Paragraphs>7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/>
  <cp:keywords/>
  <dc:description/>
  <cp:lastModifiedBy>Noelia Martínez Álvarez</cp:lastModifiedBy>
  <cp:revision>345</cp:revision>
  <cp:lastPrinted>2020-07-05T21:14:31Z</cp:lastPrinted>
  <dcterms:created xsi:type="dcterms:W3CDTF">2020-04-02T18:42:51Z</dcterms:created>
  <dcterms:modified xsi:type="dcterms:W3CDTF">2021-05-16T16:02:35Z</dcterms:modified>
  <cp:category/>
</cp:coreProperties>
</file>